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6" r:id="rId3"/>
    <p:sldId id="257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6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3544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BB4A6-FA59-4ADF-96E3-4AB942E5B9A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A3471-BBDC-44DF-8DF0-346DDD6B52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16864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BB4A6-FA59-4ADF-96E3-4AB942E5B9A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A3471-BBDC-44DF-8DF0-346DDD6B52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52874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BB4A6-FA59-4ADF-96E3-4AB942E5B9A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A3471-BBDC-44DF-8DF0-346DDD6B52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290445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BB4A6-FA59-4ADF-96E3-4AB942E5B9A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A3471-BBDC-44DF-8DF0-346DDD6B52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1295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BB4A6-FA59-4ADF-96E3-4AB942E5B9A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A3471-BBDC-44DF-8DF0-346DDD6B52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37617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BB4A6-FA59-4ADF-96E3-4AB942E5B9A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A3471-BBDC-44DF-8DF0-346DDD6B52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70213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BB4A6-FA59-4ADF-96E3-4AB942E5B9A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A3471-BBDC-44DF-8DF0-346DDD6B52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4368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BB4A6-FA59-4ADF-96E3-4AB942E5B9A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A3471-BBDC-44DF-8DF0-346DDD6B52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6441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BB4A6-FA59-4ADF-96E3-4AB942E5B9A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A3471-BBDC-44DF-8DF0-346DDD6B52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93340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BB4A6-FA59-4ADF-96E3-4AB942E5B9A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A3471-BBDC-44DF-8DF0-346DDD6B52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327163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1BB4A6-FA59-4ADF-96E3-4AB942E5B9A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EA3471-BBDC-44DF-8DF0-346DDD6B52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826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1BB4A6-FA59-4ADF-96E3-4AB942E5B9AE}" type="datetimeFigureOut">
              <a:rPr lang="de-DE" smtClean="0"/>
              <a:t>21.0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EA3471-BBDC-44DF-8DF0-346DDD6B525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83037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284" t="21359" r="2136" b="20712"/>
          <a:stretch/>
        </p:blipFill>
        <p:spPr>
          <a:xfrm>
            <a:off x="445635" y="1180618"/>
            <a:ext cx="2158562" cy="4888296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1003652" y="969968"/>
            <a:ext cx="4074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M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1356161" y="969968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MSC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2008208" y="2641320"/>
            <a:ext cx="16417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lnexin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 ~ 90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1992811" y="3808540"/>
            <a:ext cx="19319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/ACTB 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~ 45 </a:t>
            </a:r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91051" y="300848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91051" y="271582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91051" y="340343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91051" y="3808541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3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268343" y="6304806"/>
            <a:ext cx="67210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28600" indent="-228600">
              <a:buAutoNum type="alphaUcParenR"/>
            </a:pP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- The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lnexi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/ACTB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ysates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LM </a:t>
            </a:r>
          </a:p>
          <a:p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LMSC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hteck 15"/>
          <p:cNvSpPr/>
          <p:nvPr/>
        </p:nvSpPr>
        <p:spPr>
          <a:xfrm>
            <a:off x="445635" y="2558986"/>
            <a:ext cx="1562573" cy="441668"/>
          </a:xfrm>
          <a:prstGeom prst="rect">
            <a:avLst/>
          </a:prstGeom>
          <a:noFill/>
          <a:ln w="222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7" name="Rechteck 16"/>
          <p:cNvSpPr/>
          <p:nvPr/>
        </p:nvSpPr>
        <p:spPr>
          <a:xfrm>
            <a:off x="445634" y="3726206"/>
            <a:ext cx="1562573" cy="441668"/>
          </a:xfrm>
          <a:prstGeom prst="rect">
            <a:avLst/>
          </a:prstGeom>
          <a:noFill/>
          <a:ln w="222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" name="Textfeld 17"/>
          <p:cNvSpPr txBox="1"/>
          <p:nvPr/>
        </p:nvSpPr>
        <p:spPr>
          <a:xfrm>
            <a:off x="411952" y="967924"/>
            <a:ext cx="814968" cy="2790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  <a:endParaRPr lang="de-DE" sz="12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87796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95" t="14941" r="7674" b="21416"/>
          <a:stretch/>
        </p:blipFill>
        <p:spPr>
          <a:xfrm>
            <a:off x="592815" y="5278567"/>
            <a:ext cx="4886506" cy="363600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90" t="13798" r="2286" b="17285"/>
          <a:stretch/>
        </p:blipFill>
        <p:spPr>
          <a:xfrm>
            <a:off x="670882" y="548490"/>
            <a:ext cx="4645103" cy="3600000"/>
          </a:xfrm>
          <a:prstGeom prst="rect">
            <a:avLst/>
          </a:prstGeom>
        </p:spPr>
      </p:pic>
      <p:sp>
        <p:nvSpPr>
          <p:cNvPr id="8" name="Textfeld 7"/>
          <p:cNvSpPr txBox="1"/>
          <p:nvPr/>
        </p:nvSpPr>
        <p:spPr>
          <a:xfrm>
            <a:off x="988415" y="548490"/>
            <a:ext cx="33219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F1    F2  F3   F4    F5   F6    F7   F8  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848174" y="211633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848174" y="1868075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969821" y="5337736"/>
            <a:ext cx="33219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F1   F2     F3    F4     F5     F6    F7   F8  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430686" y="4251863"/>
            <a:ext cx="544999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-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vers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SA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~67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lnexi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90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,no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band)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 LM-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lat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2C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330892" y="9064107"/>
            <a:ext cx="594220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vers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SA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67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lnexi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90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band) 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– </a:t>
            </a:r>
            <a:endParaRPr lang="de-DE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condition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di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lat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2D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493590" y="649483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493590" y="627531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493590" y="6714362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848174" y="232457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2" name="Rechteck 1"/>
          <p:cNvSpPr/>
          <p:nvPr/>
        </p:nvSpPr>
        <p:spPr>
          <a:xfrm>
            <a:off x="848174" y="2116337"/>
            <a:ext cx="3443580" cy="441668"/>
          </a:xfrm>
          <a:prstGeom prst="rect">
            <a:avLst/>
          </a:prstGeom>
          <a:noFill/>
          <a:ln w="222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3" name="Textfeld 22"/>
          <p:cNvSpPr txBox="1"/>
          <p:nvPr/>
        </p:nvSpPr>
        <p:spPr>
          <a:xfrm>
            <a:off x="4291754" y="2072767"/>
            <a:ext cx="9271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SA </a:t>
            </a:r>
          </a:p>
          <a:p>
            <a:pPr algn="ctr"/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~ 67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584574" y="6493528"/>
            <a:ext cx="3707180" cy="441668"/>
          </a:xfrm>
          <a:prstGeom prst="rect">
            <a:avLst/>
          </a:prstGeom>
          <a:noFill/>
          <a:ln w="2222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5" name="Textfeld 24"/>
          <p:cNvSpPr txBox="1"/>
          <p:nvPr/>
        </p:nvSpPr>
        <p:spPr>
          <a:xfrm>
            <a:off x="4206873" y="6437363"/>
            <a:ext cx="9271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SA </a:t>
            </a:r>
          </a:p>
          <a:p>
            <a:pPr algn="ctr"/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~ 67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91319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90" t="7909" r="8114" b="21768"/>
          <a:stretch/>
        </p:blipFill>
        <p:spPr>
          <a:xfrm>
            <a:off x="931763" y="439838"/>
            <a:ext cx="4131001" cy="360000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12" t="17490" r="7145" b="15526"/>
          <a:stretch/>
        </p:blipFill>
        <p:spPr>
          <a:xfrm>
            <a:off x="701197" y="5163365"/>
            <a:ext cx="4592132" cy="3600000"/>
          </a:xfrm>
          <a:prstGeom prst="rect">
            <a:avLst/>
          </a:prstGeom>
        </p:spPr>
      </p:pic>
      <p:sp>
        <p:nvSpPr>
          <p:cNvPr id="8" name="Textfeld 7"/>
          <p:cNvSpPr txBox="1"/>
          <p:nvPr/>
        </p:nvSpPr>
        <p:spPr>
          <a:xfrm>
            <a:off x="378395" y="4147702"/>
            <a:ext cx="567845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vers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SA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67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band)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lnexi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90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,no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band)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MSC-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2C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465116" y="8887938"/>
            <a:ext cx="57678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vers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SA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67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band)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lnexin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90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band) 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ncondition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dia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2D.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1464400" y="186288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1443280" y="169000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95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1464400" y="2071128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15" name="Textfeld 14"/>
          <p:cNvSpPr txBox="1"/>
          <p:nvPr/>
        </p:nvSpPr>
        <p:spPr>
          <a:xfrm>
            <a:off x="722317" y="671962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701197" y="6546747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95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722317" y="6927866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</p:spTree>
    <p:extLst>
      <p:ext uri="{BB962C8B-B14F-4D97-AF65-F5344CB8AC3E}">
        <p14:creationId xmlns:p14="http://schemas.microsoft.com/office/powerpoint/2010/main" val="23333135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01</Words>
  <Application>Microsoft Office PowerPoint</Application>
  <PresentationFormat>A4-Papier (210 x 297 mm)</PresentationFormat>
  <Paragraphs>34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</vt:vector>
  </TitlesOfParts>
  <Company>Universitätsklinikum Frei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Naresh Polisetti</dc:creator>
  <cp:lastModifiedBy>Dr. Naresh Polisetti</cp:lastModifiedBy>
  <cp:revision>19</cp:revision>
  <dcterms:created xsi:type="dcterms:W3CDTF">2024-02-17T14:54:08Z</dcterms:created>
  <dcterms:modified xsi:type="dcterms:W3CDTF">2024-02-21T06:34:24Z</dcterms:modified>
</cp:coreProperties>
</file>